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733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12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6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436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479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52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230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19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2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62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592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16F07-A894-47EA-A12D-1B262BD7ED72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F2F39-490C-4E38-8D0E-9600BF4C4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750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smtClean="0"/>
              <a:t>Supplementary </a:t>
            </a:r>
            <a:r>
              <a:rPr lang="en-US" sz="2000" dirty="0" smtClean="0"/>
              <a:t>Figure 2. Sample </a:t>
            </a:r>
            <a:r>
              <a:rPr lang="en-US" sz="2000" dirty="0"/>
              <a:t>LAT test results for (A) positive and (B and C) negative results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4389754" y="2131695"/>
            <a:ext cx="5738983" cy="3861142"/>
            <a:chOff x="0" y="0"/>
            <a:chExt cx="3412490" cy="2594610"/>
          </a:xfrm>
        </p:grpSpPr>
        <p:grpSp>
          <p:nvGrpSpPr>
            <p:cNvPr id="5" name="Group 4"/>
            <p:cNvGrpSpPr/>
            <p:nvPr/>
          </p:nvGrpSpPr>
          <p:grpSpPr>
            <a:xfrm>
              <a:off x="0" y="0"/>
              <a:ext cx="3412490" cy="2594610"/>
              <a:chOff x="0" y="0"/>
              <a:chExt cx="3412490" cy="2594610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0" y="0"/>
                <a:ext cx="3412490" cy="2594610"/>
                <a:chOff x="0" y="0"/>
                <a:chExt cx="3412490" cy="2594610"/>
              </a:xfrm>
            </p:grpSpPr>
            <p:pic>
              <p:nvPicPr>
                <p:cNvPr id="9" name="Picture 8" descr="C:\Users\user\Downloads\IMG20220601145900.jpg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180" t="47022" r="47898" b="12785"/>
                <a:stretch/>
              </p:blipFill>
              <p:spPr bwMode="auto">
                <a:xfrm rot="5400000">
                  <a:off x="408940" y="-408940"/>
                  <a:ext cx="2594610" cy="34124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10" name="Text Box 110"/>
                <p:cNvSpPr txBox="1"/>
                <p:nvPr/>
              </p:nvSpPr>
              <p:spPr>
                <a:xfrm>
                  <a:off x="361315" y="635"/>
                  <a:ext cx="457200" cy="285750"/>
                </a:xfrm>
                <a:prstGeom prst="rect">
                  <a:avLst/>
                </a:prstGeom>
                <a:noFill/>
                <a:ln w="6350">
                  <a:noFill/>
                </a:ln>
                <a:effectLst/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1600" b="1" dirty="0">
                      <a:effectLst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</a:t>
                  </a:r>
                  <a:endParaRPr lang="en-US" sz="1100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" name="Text Box 114"/>
              <p:cNvSpPr txBox="1"/>
              <p:nvPr/>
            </p:nvSpPr>
            <p:spPr>
              <a:xfrm>
                <a:off x="1590675" y="0"/>
                <a:ext cx="371475" cy="266700"/>
              </a:xfrm>
              <a:prstGeom prst="rect">
                <a:avLst/>
              </a:prstGeom>
              <a:noFill/>
              <a:ln w="6350">
                <a:noFill/>
              </a:ln>
              <a:effectLst/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400" b="1" dirty="0">
                    <a:effectLst/>
                    <a:ea typeface="Calibri" panose="020F0502020204030204" pitchFamily="34" charset="0"/>
                    <a:cs typeface="Times New Roman" panose="02020603050405020304" pitchFamily="18" charset="0"/>
                  </a:rPr>
                  <a:t>B</a:t>
                </a:r>
                <a:endParaRPr lang="en-US" sz="11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Text Box 115"/>
            <p:cNvSpPr txBox="1"/>
            <p:nvPr/>
          </p:nvSpPr>
          <p:spPr>
            <a:xfrm>
              <a:off x="371475" y="1352550"/>
              <a:ext cx="333375" cy="295275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600" b="1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endParaRPr lang="en-US" sz="110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9801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2. Sample LAT test results for (A) positive and (B and C) negative results.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imentary figure 2 showing sampled LAT test results for (A) positive and (B and C) negative results.</dc:title>
  <dc:creator>Editor</dc:creator>
  <cp:lastModifiedBy>Editor</cp:lastModifiedBy>
  <cp:revision>3</cp:revision>
  <dcterms:created xsi:type="dcterms:W3CDTF">2023-07-03T06:44:34Z</dcterms:created>
  <dcterms:modified xsi:type="dcterms:W3CDTF">2023-07-03T06:47:13Z</dcterms:modified>
</cp:coreProperties>
</file>